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0287000" type="35mm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388" autoAdjust="0"/>
    <p:restoredTop sz="94660"/>
  </p:normalViewPr>
  <p:slideViewPr>
    <p:cSldViewPr snapToGrid="0">
      <p:cViewPr>
        <p:scale>
          <a:sx n="140" d="100"/>
          <a:sy n="140" d="100"/>
        </p:scale>
        <p:origin x="1956" y="-20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83545"/>
            <a:ext cx="5829300" cy="35814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403057"/>
            <a:ext cx="5143500" cy="248364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160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9352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47688"/>
            <a:ext cx="1478756" cy="871775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47688"/>
            <a:ext cx="4350544" cy="871775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6053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1584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564609"/>
            <a:ext cx="5915025" cy="4279106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884197"/>
            <a:ext cx="5915025" cy="2250281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9942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738438"/>
            <a:ext cx="2914650" cy="652700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738438"/>
            <a:ext cx="2914650" cy="6527007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9653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7690"/>
            <a:ext cx="5915025" cy="198834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521745"/>
            <a:ext cx="2901255" cy="12358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757613"/>
            <a:ext cx="2901255" cy="552688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521745"/>
            <a:ext cx="2915543" cy="12358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757613"/>
            <a:ext cx="2915543" cy="552688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3905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892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0838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85800"/>
            <a:ext cx="2211884" cy="24003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81140"/>
            <a:ext cx="3471863" cy="731043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86100"/>
            <a:ext cx="2211884" cy="571738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3825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85800"/>
            <a:ext cx="2211884" cy="24003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81140"/>
            <a:ext cx="3471863" cy="731043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86100"/>
            <a:ext cx="2211884" cy="571738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7557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47690"/>
            <a:ext cx="5915025" cy="19883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738438"/>
            <a:ext cx="5915025" cy="65270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534527"/>
            <a:ext cx="1543050" cy="5476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46182-E298-4F92-BA16-32B20A624723}" type="datetimeFigureOut">
              <a:rPr lang="fr-FR" smtClean="0"/>
              <a:t>08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534527"/>
            <a:ext cx="2314575" cy="5476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534527"/>
            <a:ext cx="1543050" cy="5476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CCB06-836A-4AA4-BCD4-A3C60B57B1C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4349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>
            <a:extLst>
              <a:ext uri="{FF2B5EF4-FFF2-40B4-BE49-F238E27FC236}">
                <a16:creationId xmlns:a16="http://schemas.microsoft.com/office/drawing/2014/main" id="{706CF341-718F-E44C-AFB0-67033F4F5CEF}"/>
              </a:ext>
            </a:extLst>
          </p:cNvPr>
          <p:cNvSpPr txBox="1"/>
          <p:nvPr/>
        </p:nvSpPr>
        <p:spPr>
          <a:xfrm>
            <a:off x="2000802" y="3053996"/>
            <a:ext cx="201512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7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A617B05A-FBD5-BC48-8C7C-3D00450C0B91}"/>
              </a:ext>
            </a:extLst>
          </p:cNvPr>
          <p:cNvSpPr txBox="1"/>
          <p:nvPr/>
        </p:nvSpPr>
        <p:spPr>
          <a:xfrm>
            <a:off x="2294330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14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31E573BC-FBD6-754D-94C3-C6715AC53400}"/>
              </a:ext>
            </a:extLst>
          </p:cNvPr>
          <p:cNvSpPr txBox="1"/>
          <p:nvPr/>
        </p:nvSpPr>
        <p:spPr>
          <a:xfrm>
            <a:off x="2631523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21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19C2517-13D2-BA43-B092-E8FD2ABCBDF8}"/>
              </a:ext>
            </a:extLst>
          </p:cNvPr>
          <p:cNvSpPr txBox="1"/>
          <p:nvPr/>
        </p:nvSpPr>
        <p:spPr>
          <a:xfrm>
            <a:off x="2961087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28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8141EB3-AADD-884A-ABF9-0A192625CFBC}"/>
              </a:ext>
            </a:extLst>
          </p:cNvPr>
          <p:cNvSpPr txBox="1"/>
          <p:nvPr/>
        </p:nvSpPr>
        <p:spPr>
          <a:xfrm>
            <a:off x="3298279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35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B5DB216A-9026-6B4B-906C-3A0CEFBC358F}"/>
              </a:ext>
            </a:extLst>
          </p:cNvPr>
          <p:cNvSpPr txBox="1"/>
          <p:nvPr/>
        </p:nvSpPr>
        <p:spPr>
          <a:xfrm>
            <a:off x="3627845" y="3052485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42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8EE05236-2587-EA46-9623-61A8B6CCD6B7}"/>
              </a:ext>
            </a:extLst>
          </p:cNvPr>
          <p:cNvSpPr txBox="1"/>
          <p:nvPr/>
        </p:nvSpPr>
        <p:spPr>
          <a:xfrm>
            <a:off x="3957411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49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1F2BE5D8-CBCA-8545-A7C3-5EDECB27B166}"/>
              </a:ext>
            </a:extLst>
          </p:cNvPr>
          <p:cNvSpPr txBox="1"/>
          <p:nvPr/>
        </p:nvSpPr>
        <p:spPr>
          <a:xfrm>
            <a:off x="4286976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56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24BA7C65-5FD7-E245-9A15-A1D707AFE1FD}"/>
              </a:ext>
            </a:extLst>
          </p:cNvPr>
          <p:cNvSpPr txBox="1"/>
          <p:nvPr/>
        </p:nvSpPr>
        <p:spPr>
          <a:xfrm>
            <a:off x="4616542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63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3319EAD-9F45-DE44-B570-4B62432EE1D2}"/>
              </a:ext>
            </a:extLst>
          </p:cNvPr>
          <p:cNvSpPr txBox="1"/>
          <p:nvPr/>
        </p:nvSpPr>
        <p:spPr>
          <a:xfrm>
            <a:off x="4949920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70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ED80EFDD-11F5-714D-9F9A-7F7DC4C4918E}"/>
              </a:ext>
            </a:extLst>
          </p:cNvPr>
          <p:cNvSpPr txBox="1"/>
          <p:nvPr/>
        </p:nvSpPr>
        <p:spPr>
          <a:xfrm>
            <a:off x="5279486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77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533644A-AD88-304E-B755-2B5AD2E62CFA}"/>
              </a:ext>
            </a:extLst>
          </p:cNvPr>
          <p:cNvSpPr txBox="1"/>
          <p:nvPr/>
        </p:nvSpPr>
        <p:spPr>
          <a:xfrm>
            <a:off x="5609051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84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322F88D9-AEEA-584C-A227-5378ADBDD9FF}"/>
              </a:ext>
            </a:extLst>
          </p:cNvPr>
          <p:cNvSpPr txBox="1"/>
          <p:nvPr/>
        </p:nvSpPr>
        <p:spPr>
          <a:xfrm>
            <a:off x="5934801" y="305399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91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FA2210CA-5CB9-7544-8EC3-02870B07EA23}"/>
              </a:ext>
            </a:extLst>
          </p:cNvPr>
          <p:cNvSpPr txBox="1"/>
          <p:nvPr/>
        </p:nvSpPr>
        <p:spPr>
          <a:xfrm>
            <a:off x="1670746" y="3053996"/>
            <a:ext cx="201512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0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0252C2A-74EF-6D4C-80B8-CB747CF690EC}"/>
              </a:ext>
            </a:extLst>
          </p:cNvPr>
          <p:cNvSpPr txBox="1"/>
          <p:nvPr/>
        </p:nvSpPr>
        <p:spPr>
          <a:xfrm>
            <a:off x="1560013" y="2935978"/>
            <a:ext cx="201512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0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49B321B6-732B-E443-9165-4EE5835046B6}"/>
              </a:ext>
            </a:extLst>
          </p:cNvPr>
          <p:cNvSpPr txBox="1"/>
          <p:nvPr/>
        </p:nvSpPr>
        <p:spPr>
          <a:xfrm>
            <a:off x="1507120" y="2478298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20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A694B616-9E5E-694F-A950-C0A285839A8D}"/>
              </a:ext>
            </a:extLst>
          </p:cNvPr>
          <p:cNvSpPr txBox="1"/>
          <p:nvPr/>
        </p:nvSpPr>
        <p:spPr>
          <a:xfrm>
            <a:off x="1507120" y="2020616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40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FCEC09BA-D4ED-714D-AA7C-1B9DF40899B5}"/>
              </a:ext>
            </a:extLst>
          </p:cNvPr>
          <p:cNvSpPr txBox="1"/>
          <p:nvPr/>
        </p:nvSpPr>
        <p:spPr>
          <a:xfrm>
            <a:off x="1507120" y="1562934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60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BA5ECE41-6C76-9244-9281-5F4E59A5DDDC}"/>
              </a:ext>
            </a:extLst>
          </p:cNvPr>
          <p:cNvSpPr txBox="1"/>
          <p:nvPr/>
        </p:nvSpPr>
        <p:spPr>
          <a:xfrm>
            <a:off x="1507120" y="1105252"/>
            <a:ext cx="254405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80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87B87839-DEF6-E346-83A4-48A0A9036F88}"/>
              </a:ext>
            </a:extLst>
          </p:cNvPr>
          <p:cNvSpPr txBox="1"/>
          <p:nvPr/>
        </p:nvSpPr>
        <p:spPr>
          <a:xfrm>
            <a:off x="1454226" y="647570"/>
            <a:ext cx="307299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/>
              <a:t>100</a:t>
            </a:r>
          </a:p>
        </p:txBody>
      </p:sp>
      <p:sp>
        <p:nvSpPr>
          <p:cNvPr id="33" name="Rectangle 32"/>
          <p:cNvSpPr/>
          <p:nvPr/>
        </p:nvSpPr>
        <p:spPr>
          <a:xfrm>
            <a:off x="3298208" y="2923727"/>
            <a:ext cx="1115477" cy="1731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4" name="Picture 1" descr="Plot of DCJ91Prob by DCEP1StartJ91RisqJ identified by RTX" title="Plot of DCJ91Prob by DCEP1StartJ91RisqJ identified by RTX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049" t="2145" r="2302" b="9991"/>
          <a:stretch/>
        </p:blipFill>
        <p:spPr>
          <a:xfrm>
            <a:off x="1760971" y="785639"/>
            <a:ext cx="4297357" cy="2341910"/>
          </a:xfrm>
          <a:prstGeom prst="rect">
            <a:avLst/>
          </a:prstGeom>
        </p:spPr>
      </p:pic>
      <p:sp>
        <p:nvSpPr>
          <p:cNvPr id="35" name="ZoneTexte 34">
            <a:extLst>
              <a:ext uri="{FF2B5EF4-FFF2-40B4-BE49-F238E27FC236}">
                <a16:creationId xmlns:a16="http://schemas.microsoft.com/office/drawing/2014/main" id="{3627E121-7F2D-7548-8D37-6A696E34B10F}"/>
              </a:ext>
            </a:extLst>
          </p:cNvPr>
          <p:cNvSpPr txBox="1"/>
          <p:nvPr/>
        </p:nvSpPr>
        <p:spPr>
          <a:xfrm>
            <a:off x="5643373" y="2770358"/>
            <a:ext cx="441468" cy="1853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i="1" dirty="0"/>
              <a:t>P=0.49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AC2D3604-8973-504B-A206-2A1610E8AAB5}"/>
              </a:ext>
            </a:extLst>
          </p:cNvPr>
          <p:cNvSpPr txBox="1"/>
          <p:nvPr/>
        </p:nvSpPr>
        <p:spPr>
          <a:xfrm>
            <a:off x="2" y="23147"/>
            <a:ext cx="16163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u="sng" dirty="0" err="1"/>
              <a:t>Supplemental</a:t>
            </a:r>
            <a:r>
              <a:rPr lang="fr-FR" sz="1200" b="1" u="sng" dirty="0"/>
              <a:t> Figure 1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23552951-B2E0-5947-8131-E87251DDFC08}"/>
              </a:ext>
            </a:extLst>
          </p:cNvPr>
          <p:cNvSpPr txBox="1"/>
          <p:nvPr/>
        </p:nvSpPr>
        <p:spPr>
          <a:xfrm rot="16200000">
            <a:off x="712986" y="1678098"/>
            <a:ext cx="1447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 err="1"/>
              <a:t>Probability</a:t>
            </a:r>
            <a:r>
              <a:rPr lang="fr-FR" sz="1000" b="1" dirty="0"/>
              <a:t> of </a:t>
            </a:r>
            <a:r>
              <a:rPr lang="fr-FR" sz="1000" b="1" dirty="0" err="1"/>
              <a:t>death</a:t>
            </a:r>
            <a:r>
              <a:rPr lang="fr-FR" sz="1000" b="1" dirty="0"/>
              <a:t> (%)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5CE2F78-7445-1745-AD1F-61A0DD7B603F}"/>
              </a:ext>
            </a:extLst>
          </p:cNvPr>
          <p:cNvSpPr txBox="1"/>
          <p:nvPr/>
        </p:nvSpPr>
        <p:spPr>
          <a:xfrm>
            <a:off x="2930186" y="3256770"/>
            <a:ext cx="2271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/>
              <a:t>Time </a:t>
            </a:r>
            <a:r>
              <a:rPr lang="fr-FR" sz="1000" b="1" dirty="0" err="1"/>
              <a:t>from</a:t>
            </a:r>
            <a:r>
              <a:rPr lang="fr-FR" sz="1000" b="1" dirty="0"/>
              <a:t> first plasma exchange (</a:t>
            </a:r>
            <a:r>
              <a:rPr lang="fr-FR" sz="1000" b="1" dirty="0" err="1"/>
              <a:t>days</a:t>
            </a:r>
            <a:r>
              <a:rPr lang="fr-FR" sz="1000" b="1" dirty="0"/>
              <a:t>)</a:t>
            </a: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43196B43-B176-8642-A698-4F016C2CF461}"/>
              </a:ext>
            </a:extLst>
          </p:cNvPr>
          <p:cNvGrpSpPr/>
          <p:nvPr/>
        </p:nvGrpSpPr>
        <p:grpSpPr>
          <a:xfrm>
            <a:off x="4692163" y="948619"/>
            <a:ext cx="1405855" cy="468344"/>
            <a:chOff x="4226845" y="645322"/>
            <a:chExt cx="1405855" cy="468344"/>
          </a:xfrm>
        </p:grpSpPr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83DA6EE-CC36-DB4E-B713-927402C99AAA}"/>
                </a:ext>
              </a:extLst>
            </p:cNvPr>
            <p:cNvSpPr txBox="1"/>
            <p:nvPr/>
          </p:nvSpPr>
          <p:spPr>
            <a:xfrm>
              <a:off x="4747521" y="867445"/>
              <a:ext cx="8851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No </a:t>
              </a:r>
              <a:r>
                <a:rPr lang="fr-FR" sz="1000" b="1" dirty="0" err="1"/>
                <a:t>rituximab</a:t>
              </a:r>
              <a:endParaRPr lang="fr-FR" sz="1000" b="1" dirty="0"/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C8FED2F9-034B-1A44-B39C-71616C0EDC49}"/>
                </a:ext>
              </a:extLst>
            </p:cNvPr>
            <p:cNvSpPr txBox="1"/>
            <p:nvPr/>
          </p:nvSpPr>
          <p:spPr>
            <a:xfrm>
              <a:off x="4747521" y="645322"/>
              <a:ext cx="7296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/>
                <a:t>Rituximab</a:t>
              </a:r>
              <a:endParaRPr lang="fr-FR" sz="1000" b="1" dirty="0"/>
            </a:p>
          </p:txBody>
        </p:sp>
        <p:cxnSp>
          <p:nvCxnSpPr>
            <p:cNvPr id="11" name="Connecteur droit 10">
              <a:extLst>
                <a:ext uri="{FF2B5EF4-FFF2-40B4-BE49-F238E27FC236}">
                  <a16:creationId xmlns:a16="http://schemas.microsoft.com/office/drawing/2014/main" id="{760685F4-ED25-5F4C-A5F2-0B29D4EA5FE2}"/>
                </a:ext>
              </a:extLst>
            </p:cNvPr>
            <p:cNvCxnSpPr/>
            <p:nvPr/>
          </p:nvCxnSpPr>
          <p:spPr>
            <a:xfrm>
              <a:off x="4229567" y="787780"/>
              <a:ext cx="485085" cy="0"/>
            </a:xfrm>
            <a:prstGeom prst="line">
              <a:avLst/>
            </a:prstGeom>
            <a:ln w="22225">
              <a:solidFill>
                <a:srgbClr val="043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>
              <a:extLst>
                <a:ext uri="{FF2B5EF4-FFF2-40B4-BE49-F238E27FC236}">
                  <a16:creationId xmlns:a16="http://schemas.microsoft.com/office/drawing/2014/main" id="{571949E9-617B-B749-8B49-7CCF1E14C130}"/>
                </a:ext>
              </a:extLst>
            </p:cNvPr>
            <p:cNvCxnSpPr/>
            <p:nvPr/>
          </p:nvCxnSpPr>
          <p:spPr>
            <a:xfrm>
              <a:off x="4226845" y="997328"/>
              <a:ext cx="485085" cy="0"/>
            </a:xfrm>
            <a:prstGeom prst="line">
              <a:avLst/>
            </a:prstGeom>
            <a:ln w="22225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2453235"/>
              </p:ext>
            </p:extLst>
          </p:nvPr>
        </p:nvGraphicFramePr>
        <p:xfrm>
          <a:off x="443553" y="3726489"/>
          <a:ext cx="5722516" cy="3813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50878">
                  <a:extLst>
                    <a:ext uri="{9D8B030D-6E8A-4147-A177-3AD203B41FA5}">
                      <a16:colId xmlns:a16="http://schemas.microsoft.com/office/drawing/2014/main" val="835809398"/>
                    </a:ext>
                  </a:extLst>
                </a:gridCol>
                <a:gridCol w="320722">
                  <a:extLst>
                    <a:ext uri="{9D8B030D-6E8A-4147-A177-3AD203B41FA5}">
                      <a16:colId xmlns:a16="http://schemas.microsoft.com/office/drawing/2014/main" val="1233040360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3333348217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2324536954"/>
                    </a:ext>
                  </a:extLst>
                </a:gridCol>
                <a:gridCol w="348018">
                  <a:extLst>
                    <a:ext uri="{9D8B030D-6E8A-4147-A177-3AD203B41FA5}">
                      <a16:colId xmlns:a16="http://schemas.microsoft.com/office/drawing/2014/main" val="4247353495"/>
                    </a:ext>
                  </a:extLst>
                </a:gridCol>
                <a:gridCol w="334370">
                  <a:extLst>
                    <a:ext uri="{9D8B030D-6E8A-4147-A177-3AD203B41FA5}">
                      <a16:colId xmlns:a16="http://schemas.microsoft.com/office/drawing/2014/main" val="4290835290"/>
                    </a:ext>
                  </a:extLst>
                </a:gridCol>
                <a:gridCol w="320723">
                  <a:extLst>
                    <a:ext uri="{9D8B030D-6E8A-4147-A177-3AD203B41FA5}">
                      <a16:colId xmlns:a16="http://schemas.microsoft.com/office/drawing/2014/main" val="667954498"/>
                    </a:ext>
                  </a:extLst>
                </a:gridCol>
                <a:gridCol w="334370">
                  <a:extLst>
                    <a:ext uri="{9D8B030D-6E8A-4147-A177-3AD203B41FA5}">
                      <a16:colId xmlns:a16="http://schemas.microsoft.com/office/drawing/2014/main" val="1126508617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879242085"/>
                    </a:ext>
                  </a:extLst>
                </a:gridCol>
                <a:gridCol w="320722">
                  <a:extLst>
                    <a:ext uri="{9D8B030D-6E8A-4147-A177-3AD203B41FA5}">
                      <a16:colId xmlns:a16="http://schemas.microsoft.com/office/drawing/2014/main" val="1173415005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582936186"/>
                    </a:ext>
                  </a:extLst>
                </a:gridCol>
                <a:gridCol w="334370">
                  <a:extLst>
                    <a:ext uri="{9D8B030D-6E8A-4147-A177-3AD203B41FA5}">
                      <a16:colId xmlns:a16="http://schemas.microsoft.com/office/drawing/2014/main" val="4245902408"/>
                    </a:ext>
                  </a:extLst>
                </a:gridCol>
                <a:gridCol w="316759">
                  <a:extLst>
                    <a:ext uri="{9D8B030D-6E8A-4147-A177-3AD203B41FA5}">
                      <a16:colId xmlns:a16="http://schemas.microsoft.com/office/drawing/2014/main" val="1934494639"/>
                    </a:ext>
                  </a:extLst>
                </a:gridCol>
                <a:gridCol w="338404">
                  <a:extLst>
                    <a:ext uri="{9D8B030D-6E8A-4147-A177-3AD203B41FA5}">
                      <a16:colId xmlns:a16="http://schemas.microsoft.com/office/drawing/2014/main" val="2459420102"/>
                    </a:ext>
                  </a:extLst>
                </a:gridCol>
                <a:gridCol w="338404">
                  <a:extLst>
                    <a:ext uri="{9D8B030D-6E8A-4147-A177-3AD203B41FA5}">
                      <a16:colId xmlns:a16="http://schemas.microsoft.com/office/drawing/2014/main" val="254140532"/>
                    </a:ext>
                  </a:extLst>
                </a:gridCol>
              </a:tblGrid>
              <a:tr h="119899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1" u="none" strike="noStrike" dirty="0" smtClean="0">
                          <a:effectLst/>
                        </a:rPr>
                        <a:t>Strategy\ </a:t>
                      </a:r>
                      <a:r>
                        <a:rPr lang="en-US" sz="700" b="1" u="none" strike="noStrike" dirty="0">
                          <a:effectLst/>
                        </a:rPr>
                        <a:t>at risk on day</a:t>
                      </a:r>
                      <a:endParaRPr lang="en-US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0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7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14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21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28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35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42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49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56</a:t>
                      </a:r>
                      <a:endParaRPr lang="fr-FR" sz="700" b="1" i="0" u="none" strike="noStrike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63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70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77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4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1</a:t>
                      </a:r>
                      <a:endParaRPr lang="fr-FR" sz="700" b="1" i="0" u="none" strike="noStrike" dirty="0">
                        <a:solidFill>
                          <a:srgbClr val="112277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84801318"/>
                  </a:ext>
                </a:extLst>
              </a:tr>
              <a:tr h="130714"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 smtClean="0">
                          <a:effectLst/>
                        </a:rPr>
                        <a:t>No </a:t>
                      </a:r>
                      <a:r>
                        <a:rPr lang="fr-FR" sz="700" b="1" u="none" strike="noStrike" dirty="0" err="1" smtClean="0">
                          <a:effectLst/>
                        </a:rPr>
                        <a:t>rituximab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5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3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93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93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93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>
                          <a:effectLst/>
                        </a:rPr>
                        <a:t>93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1963879"/>
                  </a:ext>
                </a:extLst>
              </a:tr>
              <a:tr h="130714"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 err="1" smtClean="0">
                          <a:effectLst/>
                        </a:rPr>
                        <a:t>Rituximab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06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05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01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00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900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9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7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7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6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6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6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6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5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700" b="1" u="none" strike="noStrike" dirty="0">
                          <a:effectLst/>
                        </a:rPr>
                        <a:t>895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053" marR="7053" marT="705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3493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01629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90</Words>
  <Application>Microsoft Office PowerPoint</Application>
  <PresentationFormat>Diapositives 35 mm</PresentationFormat>
  <Paragraphs>7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PPO Paul</dc:creator>
  <cp:lastModifiedBy>COPPO Paul</cp:lastModifiedBy>
  <cp:revision>9</cp:revision>
  <dcterms:created xsi:type="dcterms:W3CDTF">2024-08-20T15:15:43Z</dcterms:created>
  <dcterms:modified xsi:type="dcterms:W3CDTF">2024-10-08T18:11:00Z</dcterms:modified>
</cp:coreProperties>
</file>